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 autoCompressPictures="0" bookmarkIdSeed="2">
  <p:sldMasterIdLst>
    <p:sldMasterId id="2147483660" r:id="rId1"/>
  </p:sldMasterIdLst>
  <p:notesMasterIdLst>
    <p:notesMasterId r:id="rId4"/>
  </p:notesMasterIdLst>
  <p:sldIdLst>
    <p:sldId id="273" r:id="rId2"/>
    <p:sldId id="286" r:id="rId3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0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664" y="6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D8DA6FD-2EBA-4BF6-9DDA-B364D4F79689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C703604-0067-48E4-A4C0-5F034A2E907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1024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557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0961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0583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4056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7807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644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4415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26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5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02860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272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6582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2.png"/><Relationship Id="rId7" Type="http://schemas.openxmlformats.org/officeDocument/2006/relationships/image" Target="../media/image4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21146"/>
            <a:ext cx="2095500" cy="69627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2170" y="621146"/>
            <a:ext cx="3623677" cy="7156274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744583" y="6604207"/>
            <a:ext cx="1162594" cy="979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9" name="TextBox 8"/>
          <p:cNvSpPr txBox="1"/>
          <p:nvPr/>
        </p:nvSpPr>
        <p:spPr>
          <a:xfrm>
            <a:off x="720858" y="6604207"/>
            <a:ext cx="460511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200" dirty="0"/>
              <a:t>Pool</a:t>
            </a:r>
          </a:p>
          <a:p>
            <a:pPr algn="ctr"/>
            <a:r>
              <a:rPr lang="en-US" sz="1200" dirty="0"/>
              <a:t>CAC</a:t>
            </a:r>
            <a:endParaRPr lang="he-IL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337245" y="6604207"/>
            <a:ext cx="628314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1200" dirty="0"/>
              <a:t>Pool</a:t>
            </a:r>
          </a:p>
          <a:p>
            <a:pPr algn="ctr"/>
            <a:r>
              <a:rPr lang="en-US" sz="1200" dirty="0"/>
              <a:t>control</a:t>
            </a:r>
            <a:endParaRPr lang="he-IL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103858" y="436480"/>
            <a:ext cx="351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30709" y="7546846"/>
            <a:ext cx="35137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549455"/>
              </p:ext>
            </p:extLst>
          </p:nvPr>
        </p:nvGraphicFramePr>
        <p:xfrm>
          <a:off x="138285" y="9882845"/>
          <a:ext cx="3060700" cy="1871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482249" imgH="2738251" progId="Prism8.Document">
                  <p:embed/>
                </p:oleObj>
              </mc:Choice>
              <mc:Fallback>
                <p:oleObj name="Prism 8" r:id="rId4" imgW="4482249" imgH="273825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8285" y="9882845"/>
                        <a:ext cx="3060700" cy="1871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0215895"/>
              </p:ext>
            </p:extLst>
          </p:nvPr>
        </p:nvGraphicFramePr>
        <p:xfrm>
          <a:off x="3342222" y="7838795"/>
          <a:ext cx="3048000" cy="1962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463882" imgH="2874029" progId="Prism8.Document">
                  <p:embed/>
                </p:oleObj>
              </mc:Choice>
              <mc:Fallback>
                <p:oleObj name="Prism 8" r:id="rId6" imgW="4463882" imgH="287402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42222" y="7838795"/>
                        <a:ext cx="3048000" cy="1962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7120069"/>
              </p:ext>
            </p:extLst>
          </p:nvPr>
        </p:nvGraphicFramePr>
        <p:xfrm>
          <a:off x="62879" y="7722059"/>
          <a:ext cx="3211513" cy="2063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701932" imgH="3018811" progId="Prism8.Document">
                  <p:embed/>
                </p:oleObj>
              </mc:Choice>
              <mc:Fallback>
                <p:oleObj name="Prism 8" r:id="rId8" imgW="4701932" imgH="301881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2879" y="7722059"/>
                        <a:ext cx="3211513" cy="2063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4" name="Straight Arrow Connector 33"/>
          <p:cNvCxnSpPr/>
          <p:nvPr/>
        </p:nvCxnSpPr>
        <p:spPr>
          <a:xfrm flipH="1" flipV="1">
            <a:off x="5764208" y="1728777"/>
            <a:ext cx="284422" cy="39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H="1" flipV="1">
            <a:off x="5764208" y="4728032"/>
            <a:ext cx="284422" cy="39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H="1" flipV="1">
            <a:off x="5764208" y="1053578"/>
            <a:ext cx="284422" cy="39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149967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title 1">
            <a:extLst>
              <a:ext uri="{FF2B5EF4-FFF2-40B4-BE49-F238E27FC236}">
                <a16:creationId xmlns:a16="http://schemas.microsoft.com/office/drawing/2014/main" id="{762CC788-426B-480F-BBD1-36FDB8487111}"/>
              </a:ext>
            </a:extLst>
          </p:cNvPr>
          <p:cNvSpPr txBox="1">
            <a:spLocks/>
          </p:cNvSpPr>
          <p:nvPr/>
        </p:nvSpPr>
        <p:spPr>
          <a:xfrm>
            <a:off x="343094" y="468973"/>
            <a:ext cx="6171812" cy="1050111"/>
          </a:xfrm>
          <a:prstGeom prst="rect">
            <a:avLst/>
          </a:prstGeom>
        </p:spPr>
        <p:txBody>
          <a:bodyPr/>
          <a:lstStyle>
            <a:lvl1pPr marL="171450" indent="-171450" algn="r" defTabSz="685800" rtl="1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 rtl="0">
              <a:buNone/>
            </a:pPr>
            <a:r>
              <a:rPr lang="en-US" sz="1200" b="1" dirty="0">
                <a:latin typeface="Arial (body)"/>
              </a:rPr>
              <a:t>Figure S4.</a:t>
            </a:r>
            <a:r>
              <a:rPr lang="en-US" sz="1200" dirty="0">
                <a:latin typeface="Arial (body)"/>
              </a:rPr>
              <a:t> (A) Comparison of microbiota composition between donor samples originating from CAC mice (Pool CAC) or control mice (Pool control) at the genus levels. (B) Levels of </a:t>
            </a:r>
            <a:r>
              <a:rPr lang="en-US" sz="1200" i="1" dirty="0" err="1">
                <a:latin typeface="Arial (body)"/>
              </a:rPr>
              <a:t>Turicibacter</a:t>
            </a:r>
            <a:r>
              <a:rPr lang="en-US" sz="1200" dirty="0">
                <a:latin typeface="Arial (body)"/>
              </a:rPr>
              <a:t>, </a:t>
            </a:r>
            <a:r>
              <a:rPr lang="en-US" sz="1200" i="1" dirty="0">
                <a:latin typeface="Arial (body)"/>
              </a:rPr>
              <a:t>Bacteroides</a:t>
            </a:r>
            <a:r>
              <a:rPr lang="en-US" sz="1200" dirty="0">
                <a:latin typeface="Arial (body)"/>
              </a:rPr>
              <a:t> and </a:t>
            </a:r>
            <a:r>
              <a:rPr lang="en-US" sz="1200" i="1" dirty="0" err="1">
                <a:latin typeface="Arial (body)"/>
              </a:rPr>
              <a:t>Sutterella</a:t>
            </a:r>
            <a:r>
              <a:rPr lang="en-US" sz="1200" i="1" dirty="0">
                <a:latin typeface="Arial (body)"/>
              </a:rPr>
              <a:t> </a:t>
            </a:r>
            <a:r>
              <a:rPr lang="en-US" sz="1200" dirty="0">
                <a:latin typeface="Arial (body)"/>
              </a:rPr>
              <a:t>in the FMT pools (n=2-3 per group), at the start point (T1) and the end point of the experiment (T5) in CAC-FMT and control-FMT CAC mice. (n=5-9). Results are represented as mean ± SEM; p&lt;0.01=∗∗.</a:t>
            </a:r>
            <a:endParaRPr lang="en-IL" sz="1200" dirty="0">
              <a:latin typeface="Arial (body)"/>
            </a:endParaRPr>
          </a:p>
        </p:txBody>
      </p:sp>
    </p:spTree>
    <p:extLst>
      <p:ext uri="{BB962C8B-B14F-4D97-AF65-F5344CB8AC3E}">
        <p14:creationId xmlns:p14="http://schemas.microsoft.com/office/powerpoint/2010/main" val="15712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75</TotalTime>
  <Words>103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Arial (body)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28.6.2021</dc:title>
  <dc:creator>Hadas Ashkenazi</dc:creator>
  <cp:lastModifiedBy>Or Reuven</cp:lastModifiedBy>
  <cp:revision>212</cp:revision>
  <dcterms:created xsi:type="dcterms:W3CDTF">2021-06-28T09:42:38Z</dcterms:created>
  <dcterms:modified xsi:type="dcterms:W3CDTF">2023-12-24T13:20:48Z</dcterms:modified>
</cp:coreProperties>
</file>